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71993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F4CF4F-BA4A-44B2-91C9-F1129FCFDC4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822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4161600"/>
            <a:ext cx="822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6E2B76-304B-49FD-B637-49045901F9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7904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416160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416160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24160C-5BBD-4446-90CC-3EB3289949C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264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79040"/>
            <a:ext cx="264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79040"/>
            <a:ext cx="264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4161600"/>
            <a:ext cx="264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4161600"/>
            <a:ext cx="264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4161600"/>
            <a:ext cx="264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C8C5C4-FF47-44B8-9D83-6D84A709B59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79040"/>
            <a:ext cx="8229600" cy="4753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24EFEC-154C-4176-BFD6-99F19193A2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82296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175A77-4F4E-4804-A9DB-4CCD6AEBE1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40158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79040"/>
            <a:ext cx="40158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846C51-2BA6-436F-B493-3C73B99CD8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47BB6B-DB1A-4873-80AC-24FD528B22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88720"/>
            <a:ext cx="8229600" cy="5563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B86A5A-EFDC-40EC-8019-DA85F46426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79040"/>
            <a:ext cx="40158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416160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601051-598B-41C4-8274-7B533FB35D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40158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7904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416160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6598E5-7EBF-4BDC-A530-4806492EE6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7904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79040"/>
            <a:ext cx="40158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4161600"/>
            <a:ext cx="8229600" cy="2266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A90EC4-A12F-4B5C-9941-1CB1084A34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88720"/>
            <a:ext cx="8229600" cy="119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79040"/>
            <a:ext cx="8229600" cy="475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673680"/>
            <a:ext cx="2133720" cy="38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673680"/>
            <a:ext cx="2895840" cy="38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673680"/>
            <a:ext cx="2133720" cy="38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03E73B3-1C31-463D-83A6-ED398D4D510F}" type="slidenum">
              <a:rPr b="0" lang="en-I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6"/>
          <p:cNvSpPr/>
          <p:nvPr/>
        </p:nvSpPr>
        <p:spPr>
          <a:xfrm>
            <a:off x="1835280" y="4896000"/>
            <a:ext cx="5184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le S5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The confirmation of expected amplicon size of the primer pair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6"/>
          <p:cNvSpPr/>
          <p:nvPr/>
        </p:nvSpPr>
        <p:spPr>
          <a:xfrm>
            <a:off x="539640" y="1368360"/>
            <a:ext cx="8286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primer pairs were tested before qRT-PCR, using cDNA by standard PCR reaction with Mycycler Gradient (BioRad). The amplicons size were verified in  2% agarose gel electrophoresis and ethidium bromide staining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Group 10"/>
          <p:cNvGrpSpPr/>
          <p:nvPr/>
        </p:nvGrpSpPr>
        <p:grpSpPr>
          <a:xfrm>
            <a:off x="1476360" y="2952720"/>
            <a:ext cx="5616720" cy="1644840"/>
            <a:chOff x="1476360" y="2952720"/>
            <a:chExt cx="5616720" cy="1644840"/>
          </a:xfrm>
        </p:grpSpPr>
        <p:grpSp>
          <p:nvGrpSpPr>
            <p:cNvPr id="44" name="Group 9"/>
            <p:cNvGrpSpPr/>
            <p:nvPr/>
          </p:nvGrpSpPr>
          <p:grpSpPr>
            <a:xfrm>
              <a:off x="1764000" y="2952720"/>
              <a:ext cx="5329080" cy="1644840"/>
              <a:chOff x="1764000" y="2952720"/>
              <a:chExt cx="5329080" cy="1644840"/>
            </a:xfrm>
          </p:grpSpPr>
          <p:pic>
            <p:nvPicPr>
              <p:cNvPr id="45" name="Picture 7" descr=""/>
              <p:cNvPicPr/>
              <p:nvPr/>
            </p:nvPicPr>
            <p:blipFill>
              <a:blip r:embed="rId1"/>
              <a:stretch/>
            </p:blipFill>
            <p:spPr>
              <a:xfrm>
                <a:off x="1764000" y="3168720"/>
                <a:ext cx="5329080" cy="1428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6" name="TextBox 13"/>
              <p:cNvSpPr/>
              <p:nvPr/>
            </p:nvSpPr>
            <p:spPr>
              <a:xfrm>
                <a:off x="1805400" y="2952720"/>
                <a:ext cx="5215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Calibri"/>
                  </a:rPr>
                  <a:t>M     CAC    ACP    ELFA   GAP   TMD     SNF     TIPS    TSB    TUA    ZNF   UBQ9  AC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7" name="TextBox 9"/>
            <p:cNvSpPr/>
            <p:nvPr/>
          </p:nvSpPr>
          <p:spPr>
            <a:xfrm>
              <a:off x="1476360" y="3168360"/>
              <a:ext cx="360360" cy="10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5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3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01T06:51:40Z</dcterms:created>
  <dc:creator>NCB203</dc:creator>
  <dc:description/>
  <dc:language>en-US</dc:language>
  <cp:lastModifiedBy>NIPGR</cp:lastModifiedBy>
  <dcterms:modified xsi:type="dcterms:W3CDTF">2012-04-18T11:54:45Z</dcterms:modified>
  <cp:revision>93</cp:revision>
  <dc:subject/>
  <dc:title>Slide 1</dc:title>
</cp:coreProperties>
</file>